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772400" cy="100584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F3D7A28D-5342-4CD0-BAE4-1319E1F23882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828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478D6E07-06BD-493F-95C4-6593EEE18E4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82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3520" y="39682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FFE446EE-AEEC-4347-AA28-166F6C578A4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280" y="16048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1360" y="16048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82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280" y="39682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1360" y="39682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1725DEE-ED1D-4A1A-8B90-FD1466DD4407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488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142B029-54BF-4E40-87AF-18FC96FD82E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E52E124-56D9-4440-A4AC-1D3A98A5E61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1A1219BB-623F-4578-90EE-54DDC33D4BA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E15D294B-2C81-45BF-BAB0-96FD5497B20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2520"/>
            <a:ext cx="822816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2BC3B11F-0F7C-4187-945B-81A962B6E52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82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08E99F8-F572-4C93-BED3-67797EF89E7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3520" y="39682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2A59C022-C0DE-4DA2-BCAF-45D574CDE04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828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A8A1C7BB-3C1B-48E2-9FD7-7C8A4DCCAD7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dt" idx="1"/>
          </p:nvPr>
        </p:nvSpPr>
        <p:spPr>
          <a:xfrm>
            <a:off x="457200" y="6356160"/>
            <a:ext cx="2131920" cy="3632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10/8/1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"/>
          <p:cNvSpPr/>
          <p:nvPr/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2"/>
          <p:cNvSpPr>
            <a:spLocks noGrp="1"/>
          </p:cNvSpPr>
          <p:nvPr>
            <p:ph type="sldNum" idx="2"/>
          </p:nvPr>
        </p:nvSpPr>
        <p:spPr>
          <a:xfrm>
            <a:off x="6552720" y="6356160"/>
            <a:ext cx="2132280" cy="3632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A809344D-2C53-476C-8D07-B59DC803C1E6}" type="slidenum">
              <a:rPr b="0" lang="en-US" sz="18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3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body"/>
          </p:nvPr>
        </p:nvSpPr>
        <p:spPr>
          <a:xfrm>
            <a:off x="457200" y="160488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99000"/>
          </a:bodyPr>
          <a:p>
            <a:pPr marL="339480" indent="0">
              <a:lnSpc>
                <a:spcPct val="102000"/>
              </a:lnSpc>
              <a:spcAft>
                <a:spcPts val="1426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339480" indent="-3394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339480" indent="-3394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339480" indent="-3394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339480" indent="-3394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339480" indent="-3394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339480" indent="-3394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812880" y="189000"/>
            <a:ext cx="8080200" cy="41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Additional file 3:  Figure S3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1979640" y="981000"/>
            <a:ext cx="5353200" cy="5462640"/>
            <a:chOff x="1979640" y="981000"/>
            <a:chExt cx="5353200" cy="5462640"/>
          </a:xfrm>
        </p:grpSpPr>
        <p:sp>
          <p:nvSpPr>
            <p:cNvPr id="43" name=""/>
            <p:cNvSpPr/>
            <p:nvPr/>
          </p:nvSpPr>
          <p:spPr>
            <a:xfrm>
              <a:off x="1979640" y="981000"/>
              <a:ext cx="5353200" cy="546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 rot="16200000">
              <a:off x="2486880" y="3542760"/>
              <a:ext cx="819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2396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X2776_pos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 rot="16200000">
              <a:off x="2779920" y="4756320"/>
              <a:ext cx="750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2396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X1591_pr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 rot="16200000">
              <a:off x="3007440" y="4758480"/>
              <a:ext cx="819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2396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X1591_pos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 rot="16200000">
              <a:off x="3303720" y="3202200"/>
              <a:ext cx="750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2396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X2776_pr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 rot="16200000">
              <a:off x="3564000" y="4873680"/>
              <a:ext cx="750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2396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X1846_pr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 rot="16200000">
              <a:off x="3782160" y="4876200"/>
              <a:ext cx="819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2396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X1846_pos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 rot="16200000">
              <a:off x="4044240" y="4450680"/>
              <a:ext cx="819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2396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X2789_pos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 rot="16200000">
              <a:off x="4338720" y="4449960"/>
              <a:ext cx="750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2396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X2789_pr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 rot="16200000">
              <a:off x="4556520" y="4410720"/>
              <a:ext cx="835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2396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X1351_pre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 rot="16200000">
              <a:off x="4784400" y="4855320"/>
              <a:ext cx="9043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2396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X1351_post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 rot="16200000">
              <a:off x="5044680" y="4974480"/>
              <a:ext cx="9043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2396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X1351_post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 rot="16200000">
              <a:off x="5340960" y="4973760"/>
              <a:ext cx="835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2396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X1351_pre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 rot="16200000">
              <a:off x="5603040" y="4392000"/>
              <a:ext cx="819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2396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X1850_pos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 rot="16200000">
              <a:off x="5896080" y="4389480"/>
              <a:ext cx="750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2396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X1850_pr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 rot="16200000">
              <a:off x="6125400" y="4183920"/>
              <a:ext cx="819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2396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X1986_pos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 rot="16200000">
              <a:off x="6419880" y="4181760"/>
              <a:ext cx="750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2396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X1986_pr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 flipV="1">
              <a:off x="2733840" y="1751040"/>
              <a:ext cx="1440" cy="2557440"/>
            </a:xfrm>
            <a:prstGeom prst="line">
              <a:avLst/>
            </a:prstGeom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 flipH="1">
              <a:off x="2644560" y="4307040"/>
              <a:ext cx="90360" cy="1440"/>
            </a:xfrm>
            <a:prstGeom prst="line">
              <a:avLst/>
            </a:prstGeom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 flipH="1">
              <a:off x="2644560" y="3919680"/>
              <a:ext cx="90360" cy="1440"/>
            </a:xfrm>
            <a:prstGeom prst="line">
              <a:avLst/>
            </a:prstGeom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 flipH="1">
              <a:off x="2644560" y="3533760"/>
              <a:ext cx="90360" cy="1440"/>
            </a:xfrm>
            <a:prstGeom prst="line">
              <a:avLst/>
            </a:prstGeom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 flipH="1">
              <a:off x="2644560" y="3137040"/>
              <a:ext cx="90360" cy="1440"/>
            </a:xfrm>
            <a:prstGeom prst="line">
              <a:avLst/>
            </a:prstGeom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 flipH="1">
              <a:off x="2644560" y="2752560"/>
              <a:ext cx="90360" cy="1800"/>
            </a:xfrm>
            <a:prstGeom prst="line">
              <a:avLst/>
            </a:prstGeom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 flipH="1">
              <a:off x="2644560" y="2365200"/>
              <a:ext cx="90360" cy="1800"/>
            </a:xfrm>
            <a:prstGeom prst="line">
              <a:avLst/>
            </a:prstGeom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 flipH="1">
              <a:off x="2644560" y="1981080"/>
              <a:ext cx="90360" cy="1800"/>
            </a:xfrm>
            <a:prstGeom prst="line">
              <a:avLst/>
            </a:prstGeom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 rot="16200000">
              <a:off x="2315160" y="4214520"/>
              <a:ext cx="299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.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 rot="16200000">
              <a:off x="2315160" y="3444480"/>
              <a:ext cx="299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.1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 rot="16200000">
              <a:off x="2315160" y="2661840"/>
              <a:ext cx="299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.2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 rot="16200000">
              <a:off x="2315160" y="1888920"/>
              <a:ext cx="299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.3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3021120" y="1266840"/>
              <a:ext cx="36460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23960"/>
                  <a:tab algn="l" pos="1447920"/>
                  <a:tab algn="l" pos="2171880"/>
                  <a:tab algn="l" pos="2895480"/>
                  <a:tab algn="l" pos="361944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luster dendrogram with AU/BP values (%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 rot="16200000">
              <a:off x="1876680" y="3523320"/>
              <a:ext cx="4428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Heigh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5318280" y="419724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ff0000"/>
                  </a:solidFill>
                  <a:latin typeface="Arial"/>
                  <a:ea typeface="ＭＳ Ｐゴシック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3760920" y="410832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ff0000"/>
                  </a:solidFill>
                  <a:latin typeface="Arial"/>
                  <a:ea typeface="ＭＳ Ｐゴシック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5126040" y="407844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ff0000"/>
                  </a:solidFill>
                  <a:latin typeface="Arial"/>
                  <a:ea typeface="ＭＳ Ｐゴシック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2986200" y="397980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ff0000"/>
                  </a:solidFill>
                  <a:latin typeface="Arial"/>
                  <a:ea typeface="ＭＳ Ｐゴシック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4284720" y="367200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ff0000"/>
                  </a:solidFill>
                  <a:latin typeface="Arial"/>
                  <a:ea typeface="ＭＳ Ｐゴシック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4903920" y="363204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ff0000"/>
                  </a:solidFill>
                  <a:latin typeface="Arial"/>
                  <a:ea typeface="ＭＳ Ｐゴシック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5842080" y="362268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ff0000"/>
                  </a:solidFill>
                  <a:latin typeface="Arial"/>
                  <a:ea typeface="ＭＳ Ｐゴシック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6364440" y="341460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ff0000"/>
                  </a:solidFill>
                  <a:latin typeface="Arial"/>
                  <a:ea typeface="ＭＳ Ｐゴシック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6177240" y="298944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ff0000"/>
                  </a:solidFill>
                  <a:latin typeface="Arial"/>
                  <a:ea typeface="ＭＳ Ｐゴシック"/>
                </a:rPr>
                <a:t>9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2793960" y="276228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ff0000"/>
                  </a:solidFill>
                  <a:latin typeface="Arial"/>
                  <a:ea typeface="ＭＳ Ｐゴシック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5577120" y="258444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ff0000"/>
                  </a:solidFill>
                  <a:latin typeface="Arial"/>
                  <a:ea typeface="ＭＳ Ｐゴシック"/>
                </a:rPr>
                <a:t>9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3641760" y="24256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ff0000"/>
                  </a:solidFill>
                  <a:latin typeface="Arial"/>
                  <a:ea typeface="ＭＳ Ｐゴシック"/>
                </a:rPr>
                <a:t>7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3254400" y="218772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ff0000"/>
                  </a:solidFill>
                  <a:latin typeface="Arial"/>
                  <a:ea typeface="ＭＳ Ｐゴシック"/>
                </a:rPr>
                <a:t>9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4967280" y="19512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ff0000"/>
                  </a:solidFill>
                  <a:latin typeface="Arial"/>
                  <a:ea typeface="ＭＳ Ｐゴシック"/>
                </a:rPr>
                <a:t>9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4105440" y="179244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ff0000"/>
                  </a:solidFill>
                  <a:latin typeface="Arial"/>
                  <a:ea typeface="ＭＳ Ｐゴシック"/>
                </a:rPr>
                <a:t>au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5707080" y="419724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cd00"/>
                  </a:solidFill>
                  <a:latin typeface="Arial"/>
                  <a:ea typeface="ＭＳ Ｐゴシック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4148280" y="410832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cd00"/>
                  </a:solidFill>
                  <a:latin typeface="Arial"/>
                  <a:ea typeface="ＭＳ Ｐゴシック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5514840" y="407844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cd00"/>
                  </a:solidFill>
                  <a:latin typeface="Arial"/>
                  <a:ea typeface="ＭＳ Ｐゴシック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3363840" y="397980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cd00"/>
                  </a:solidFill>
                  <a:latin typeface="Arial"/>
                  <a:ea typeface="ＭＳ Ｐゴシック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4672080" y="367200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cd00"/>
                  </a:solidFill>
                  <a:latin typeface="Arial"/>
                  <a:ea typeface="ＭＳ Ｐゴシック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5281560" y="363204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cd00"/>
                  </a:solidFill>
                  <a:latin typeface="Arial"/>
                  <a:ea typeface="ＭＳ Ｐゴシック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6230880" y="362268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cd00"/>
                  </a:solidFill>
                  <a:latin typeface="Arial"/>
                  <a:ea typeface="ＭＳ Ｐゴシック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6743880" y="341460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cd00"/>
                  </a:solidFill>
                  <a:latin typeface="Arial"/>
                  <a:ea typeface="ＭＳ Ｐゴシック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6486840" y="298944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cd00"/>
                  </a:solidFill>
                  <a:latin typeface="Arial"/>
                  <a:ea typeface="ＭＳ Ｐゴシック"/>
                </a:rPr>
                <a:t>9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3171960" y="276228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cd00"/>
                  </a:solidFill>
                  <a:latin typeface="Arial"/>
                  <a:ea typeface="ＭＳ Ｐゴシック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5878800" y="258444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cd00"/>
                  </a:solidFill>
                  <a:latin typeface="Arial"/>
                  <a:ea typeface="ＭＳ Ｐゴシック"/>
                </a:rPr>
                <a:t>9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3953160" y="24256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cd00"/>
                  </a:solidFill>
                  <a:latin typeface="Arial"/>
                  <a:ea typeface="ＭＳ Ｐゴシック"/>
                </a:rPr>
                <a:t>5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3564000" y="218772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cd00"/>
                  </a:solidFill>
                  <a:latin typeface="Arial"/>
                  <a:ea typeface="ＭＳ Ｐゴシック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5278680" y="19512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cd00"/>
                  </a:solidFill>
                  <a:latin typeface="Arial"/>
                  <a:ea typeface="ＭＳ Ｐゴシック"/>
                </a:rPr>
                <a:t>4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4416480" y="179244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cd00"/>
                  </a:solidFill>
                  <a:latin typeface="Arial"/>
                  <a:ea typeface="ＭＳ Ｐゴシック"/>
                </a:rPr>
                <a:t>b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5583240" y="43466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bebebe"/>
                  </a:solidFill>
                  <a:latin typeface="Arial"/>
                  <a:ea typeface="ＭＳ Ｐゴシック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4024440" y="42559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bebebe"/>
                  </a:solidFill>
                  <a:latin typeface="Arial"/>
                  <a:ea typeface="ＭＳ Ｐゴシック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5391360" y="42274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bebebe"/>
                  </a:solidFill>
                  <a:latin typeface="Arial"/>
                  <a:ea typeface="ＭＳ Ｐゴシック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3249720" y="412740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bebebe"/>
                  </a:solidFill>
                  <a:latin typeface="Arial"/>
                  <a:ea typeface="ＭＳ Ｐゴシック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4548240" y="38210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bebebe"/>
                  </a:solidFill>
                  <a:latin typeface="Arial"/>
                  <a:ea typeface="ＭＳ Ｐゴシック"/>
                </a:rPr>
                <a:t>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5167440" y="37814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bebebe"/>
                  </a:solidFill>
                  <a:latin typeface="Arial"/>
                  <a:ea typeface="ＭＳ Ｐゴシック"/>
                </a:rPr>
                <a:t>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6107400" y="37702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bebebe"/>
                  </a:solidFill>
                  <a:latin typeface="Arial"/>
                  <a:ea typeface="ＭＳ Ｐゴシック"/>
                </a:rPr>
                <a:t>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6629400" y="356400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bebebe"/>
                  </a:solidFill>
                  <a:latin typeface="Arial"/>
                  <a:ea typeface="ＭＳ Ｐゴシック"/>
                </a:rPr>
                <a:t>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6367680" y="31384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bebebe"/>
                  </a:solidFill>
                  <a:latin typeface="Arial"/>
                  <a:ea typeface="ＭＳ Ｐゴシック"/>
                </a:rPr>
                <a:t>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3013200" y="29098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bebebe"/>
                  </a:solidFill>
                  <a:latin typeface="Arial"/>
                  <a:ea typeface="ＭＳ Ｐゴシック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5733000" y="273204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bebebe"/>
                  </a:solidFill>
                  <a:latin typeface="Arial"/>
                  <a:ea typeface="ＭＳ Ｐゴシック"/>
                </a:rPr>
                <a:t>1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3797640" y="25732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bebebe"/>
                  </a:solidFill>
                  <a:latin typeface="Arial"/>
                  <a:ea typeface="ＭＳ Ｐゴシック"/>
                </a:rPr>
                <a:t>1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3410280" y="23367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bebebe"/>
                  </a:solidFill>
                  <a:latin typeface="Arial"/>
                  <a:ea typeface="ＭＳ Ｐゴシック"/>
                </a:rPr>
                <a:t>1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5123160" y="20988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bebebe"/>
                  </a:solidFill>
                  <a:latin typeface="Arial"/>
                  <a:ea typeface="ＭＳ Ｐゴシック"/>
                </a:rPr>
                <a:t>1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4138560" y="1941480"/>
              <a:ext cx="386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bebebe"/>
                  </a:solidFill>
                  <a:latin typeface="Arial"/>
                  <a:ea typeface="ＭＳ Ｐゴシック"/>
                </a:rPr>
                <a:t>edge #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/>
  <cp:revision>0</cp:revision>
  <dc:subject/>
  <dc:title/>
</cp:coreProperties>
</file>